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7.xml" ContentType="application/vnd.ms-office.chartcolorstyle+xml"/>
  <Override PartName="/ppt/charts/style7.xml" ContentType="application/vnd.ms-office.chartstyle+xml"/>
  <Override PartName="/ppt/charts/colors8.xml" ContentType="application/vnd.ms-office.chartcolorstyle+xml"/>
  <Override PartName="/ppt/charts/style8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6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bin Wang" initials="LW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37F5"/>
    <a:srgbClr val="595959"/>
    <a:srgbClr val="C00000"/>
    <a:srgbClr val="2C251B"/>
    <a:srgbClr val="262219"/>
    <a:srgbClr val="FCFDF5"/>
    <a:srgbClr val="573EEE"/>
    <a:srgbClr val="E7E6E6"/>
    <a:srgbClr val="FFE1E1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07" autoAdjust="0"/>
    <p:restoredTop sz="93826" autoAdjust="0"/>
  </p:normalViewPr>
  <p:slideViewPr>
    <p:cSldViewPr snapToGrid="0" showGuides="1">
      <p:cViewPr>
        <p:scale>
          <a:sx n="123" d="100"/>
          <a:sy n="123" d="100"/>
        </p:scale>
        <p:origin x="-168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7.xml"/><Relationship Id="rId2" Type="http://schemas.microsoft.com/office/2011/relationships/chartColorStyle" Target="colors7.xml"/><Relationship Id="rId1" Type="http://schemas.openxmlformats.org/officeDocument/2006/relationships/oleObject" Target="file:///C:\Users\pc\Desktop\Yali%20O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8.xml"/><Relationship Id="rId2" Type="http://schemas.microsoft.com/office/2011/relationships/chartColorStyle" Target="colors8.xml"/><Relationship Id="rId1" Type="http://schemas.openxmlformats.org/officeDocument/2006/relationships/oleObject" Target="file:///C:\Users\pc\Desktop\Yali%20O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93378381029543"/>
          <c:y val="4.8649996480168212E-2"/>
          <c:w val="0.80150128376751018"/>
          <c:h val="0.7620707358342618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3EF-4472-A1AB-B7FEC5660A85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3EF-4472-A1AB-B7FEC5660A85}"/>
              </c:ext>
            </c:extLst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C20D-4716-919A-3A55913121FE}"/>
                </c:ext>
              </c:extLst>
            </c:dLbl>
            <c:dLbl>
              <c:idx val="1"/>
              <c:layout>
                <c:manualLayout>
                  <c:x val="-1.131038942860028E-16"/>
                  <c:y val="-2.5380710659898522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rgbClr val="C00000"/>
                        </a:solidFill>
                      </a:rPr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63EF-4472-A1AB-B7FEC5660A85}"/>
                </c:ext>
              </c:extLst>
            </c:dLbl>
            <c:dLbl>
              <c:idx val="2"/>
              <c:layout>
                <c:manualLayout>
                  <c:x val="0"/>
                  <c:y val="-4.5685279187817306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rgbClr val="C00000"/>
                        </a:solidFill>
                      </a:rPr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63EF-4472-A1AB-B7FEC5660A8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5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N$4:$N$6</c:f>
                <c:numCache>
                  <c:formatCode>General</c:formatCode>
                  <c:ptCount val="3"/>
                  <c:pt idx="0">
                    <c:v>0.01</c:v>
                  </c:pt>
                  <c:pt idx="1">
                    <c:v>9.643650760992957E-2</c:v>
                  </c:pt>
                  <c:pt idx="2">
                    <c:v>0.14468356276140365</c:v>
                  </c:pt>
                </c:numCache>
              </c:numRef>
            </c:plus>
            <c:minus>
              <c:numRef>
                <c:f>Sheet1!$N$4:$N$6</c:f>
                <c:numCache>
                  <c:formatCode>General</c:formatCode>
                  <c:ptCount val="3"/>
                  <c:pt idx="0">
                    <c:v>0.01</c:v>
                  </c:pt>
                  <c:pt idx="1">
                    <c:v>9.643650760992957E-2</c:v>
                  </c:pt>
                  <c:pt idx="2">
                    <c:v>0.1446835627614036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L$4:$L$6</c:f>
              <c:strCache>
                <c:ptCount val="3"/>
                <c:pt idx="0">
                  <c:v>Control</c:v>
                </c:pt>
                <c:pt idx="1">
                  <c:v>OE-8</c:v>
                </c:pt>
                <c:pt idx="2">
                  <c:v>OE-13</c:v>
                </c:pt>
              </c:strCache>
            </c:strRef>
          </c:cat>
          <c:val>
            <c:numRef>
              <c:f>Sheet1!$M$4:$M$6</c:f>
              <c:numCache>
                <c:formatCode>0.00_);[Red]\(0.00\)</c:formatCode>
                <c:ptCount val="3"/>
                <c:pt idx="0">
                  <c:v>0.01</c:v>
                </c:pt>
                <c:pt idx="1">
                  <c:v>1.0000000000000002</c:v>
                </c:pt>
                <c:pt idx="2">
                  <c:v>1.06333333333333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63EF-4472-A1AB-B7FEC5660A85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369078784"/>
        <c:axId val="368848832"/>
      </c:barChart>
      <c:catAx>
        <c:axId val="3690787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/>
                  <a:t>Sample</a:t>
                </a:r>
                <a:endParaRPr lang="zh-CN" altLang="en-US" sz="900"/>
              </a:p>
            </c:rich>
          </c:tx>
          <c:layout>
            <c:manualLayout>
              <c:xMode val="edge"/>
              <c:yMode val="edge"/>
              <c:x val="0.50102511202637001"/>
              <c:y val="0.9295551380950477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68848832"/>
        <c:crosses val="autoZero"/>
        <c:auto val="1"/>
        <c:lblAlgn val="ctr"/>
        <c:lblOffset val="100"/>
        <c:noMultiLvlLbl val="0"/>
      </c:catAx>
      <c:valAx>
        <c:axId val="368848832"/>
        <c:scaling>
          <c:orientation val="minMax"/>
          <c:max val="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i="1" dirty="0"/>
                  <a:t>PbrWRKY62</a:t>
                </a:r>
                <a:r>
                  <a:rPr lang="en-US" altLang="zh-CN" sz="900" dirty="0"/>
                  <a:t> expression level</a:t>
                </a:r>
                <a:endParaRPr lang="zh-CN" altLang="en-US" sz="900" dirty="0"/>
              </a:p>
            </c:rich>
          </c:tx>
          <c:layout>
            <c:manualLayout>
              <c:xMode val="edge"/>
              <c:yMode val="edge"/>
              <c:x val="0"/>
              <c:y val="0.1871245853151604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_);[Red]\(#,##0.0\)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6907878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8472589152927865"/>
          <c:y val="3.0456852791878174E-2"/>
          <c:w val="0.31590986980919389"/>
          <c:h val="7.219233382629201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5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rgbClr val="FFFF00"/>
    </a:solidFill>
    <a:ln w="9525" cap="flat" cmpd="sng" algn="ctr">
      <a:noFill/>
      <a:round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PH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93378381029543"/>
          <c:y val="4.8649996480168212E-2"/>
          <c:w val="0.80150128376751018"/>
          <c:h val="0.7620707358342618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4DF3-4F1C-9214-ADE5C9C8D1EA}"/>
              </c:ext>
            </c:extLst>
          </c:dPt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D57-4C97-B7F7-DA883CD6EB6B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D57-4C97-B7F7-DA883CD6EB6B}"/>
              </c:ext>
            </c:extLst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rgbClr val="595959"/>
                        </a:solidFill>
                      </a:rPr>
                      <a:t>b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4DF3-4F1C-9214-ADE5C9C8D1EA}"/>
                </c:ext>
              </c:extLst>
            </c:dLbl>
            <c:dLbl>
              <c:idx val="1"/>
              <c:layout>
                <c:manualLayout>
                  <c:x val="-1.131038942860028E-16"/>
                  <c:y val="-2.5380710659898522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rgbClr val="C00000"/>
                        </a:solidFill>
                      </a:rPr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3D57-4C97-B7F7-DA883CD6EB6B}"/>
                </c:ext>
              </c:extLst>
            </c:dLbl>
            <c:dLbl>
              <c:idx val="2"/>
              <c:layout>
                <c:manualLayout>
                  <c:x val="0"/>
                  <c:y val="-4.060913705583756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rgbClr val="C00000"/>
                        </a:solidFill>
                      </a:rPr>
                      <a:t>a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3D57-4C97-B7F7-DA883CD6EB6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5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N$4:$N$6</c:f>
                <c:numCache>
                  <c:formatCode>General</c:formatCode>
                  <c:ptCount val="3"/>
                  <c:pt idx="0">
                    <c:v>0.01</c:v>
                  </c:pt>
                  <c:pt idx="1">
                    <c:v>9.643650760992957E-2</c:v>
                  </c:pt>
                  <c:pt idx="2">
                    <c:v>0.14468356276140365</c:v>
                  </c:pt>
                </c:numCache>
              </c:numRef>
            </c:plus>
            <c:minus>
              <c:numRef>
                <c:f>Sheet1!$N$4:$N$6</c:f>
                <c:numCache>
                  <c:formatCode>General</c:formatCode>
                  <c:ptCount val="3"/>
                  <c:pt idx="0">
                    <c:v>0.01</c:v>
                  </c:pt>
                  <c:pt idx="1">
                    <c:v>9.643650760992957E-2</c:v>
                  </c:pt>
                  <c:pt idx="2">
                    <c:v>0.1446835627614036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Sheet1!$L$10:$L$12</c:f>
              <c:strCache>
                <c:ptCount val="3"/>
                <c:pt idx="0">
                  <c:v>Control</c:v>
                </c:pt>
                <c:pt idx="1">
                  <c:v>OE-6</c:v>
                </c:pt>
                <c:pt idx="2">
                  <c:v>OE-9</c:v>
                </c:pt>
              </c:strCache>
            </c:strRef>
          </c:cat>
          <c:val>
            <c:numRef>
              <c:f>Sheet1!$M$10:$M$12</c:f>
              <c:numCache>
                <c:formatCode>0.00_);[Red]\(0.00\)</c:formatCode>
                <c:ptCount val="3"/>
                <c:pt idx="0">
                  <c:v>1.6666666666666666E-2</c:v>
                </c:pt>
                <c:pt idx="1">
                  <c:v>1</c:v>
                </c:pt>
                <c:pt idx="2">
                  <c:v>0.933333333333333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3D57-4C97-B7F7-DA883CD6EB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369079808"/>
        <c:axId val="368850560"/>
      </c:barChart>
      <c:catAx>
        <c:axId val="3690798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/>
                  <a:t>Sample</a:t>
                </a:r>
                <a:endParaRPr lang="zh-CN" altLang="en-US" sz="900"/>
              </a:p>
            </c:rich>
          </c:tx>
          <c:layout>
            <c:manualLayout>
              <c:xMode val="edge"/>
              <c:yMode val="edge"/>
              <c:x val="0.50719448661937949"/>
              <c:y val="0.9194028538310882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68850560"/>
        <c:crosses val="autoZero"/>
        <c:auto val="1"/>
        <c:lblAlgn val="ctr"/>
        <c:lblOffset val="100"/>
        <c:noMultiLvlLbl val="0"/>
      </c:catAx>
      <c:valAx>
        <c:axId val="368850560"/>
        <c:scaling>
          <c:orientation val="minMax"/>
          <c:max val="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i="1" dirty="0"/>
                  <a:t>PbrADC1</a:t>
                </a:r>
                <a:r>
                  <a:rPr lang="en-US" altLang="zh-CN" sz="900" dirty="0"/>
                  <a:t> expression level</a:t>
                </a:r>
                <a:endParaRPr lang="zh-CN" altLang="en-US" sz="900" dirty="0"/>
              </a:p>
            </c:rich>
          </c:tx>
          <c:layout>
            <c:manualLayout>
              <c:xMode val="edge"/>
              <c:yMode val="edge"/>
              <c:x val="3.0895450717748434E-3"/>
              <c:y val="0.1718961589192214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_);[Red]\(#,##0.0\)" sourceLinked="0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690798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9475112524291913"/>
          <c:y val="3.0456852791878174E-2"/>
          <c:w val="0.30202877697492247"/>
          <c:h val="7.219233382629201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5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rgbClr val="FFFF00"/>
    </a:solidFill>
    <a:ln w="9525" cap="flat" cmpd="sng" algn="ctr">
      <a:noFill/>
      <a:round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DC98CC-2AF8-4FD9-9E7C-A0C24A633DA4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6B2C4D-6130-4C66-A9EA-5780B903F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924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D041859-A63D-D772-A264-D8268EED4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6CCCB1A6-1850-A204-EFC8-935362ED36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E6D255A-D39E-1B89-DA22-0D857B19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B4B678B-4D53-0E79-94FE-D89F62B87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35BB68D-1861-C39F-CD55-5EAF6F274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903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BC58309-37E9-1FA2-1B15-848BA5953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7F40BB7-8014-3649-D669-7DC7C0F4F1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0CA863B-B0B0-A8AE-B6C6-211D398A1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DA641A1-65C2-AC4B-AA6D-4CC2A6F15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FF6CADC-D53C-BBEF-A153-069C3F45C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651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49F0F66F-44D4-93F8-08CE-6060D460B6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975C86ED-E11C-8312-1A8B-3015B5557D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42627D1-5E73-95CF-1A8F-4CA518906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4EF8AB0-7893-F50A-DFE5-D548AFEA1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C3F96BB-937C-9DA4-34DA-F6D0E319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322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8F29EE3-B57C-5B3E-B03F-A49145BD0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DA8F29E-75A5-C7EF-8C94-DD2E429D42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83F43F0-2694-FF88-78ED-A4F861677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C0A3F80-0733-EAFF-5BBC-4C2B8EAEB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160031D-F379-50CF-D5CF-627155DD1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36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09319F5-5DA5-9777-E5F7-92F893FD9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8BA2A9E-22C3-625A-E97D-6DA5C6DA8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D09C20-3367-D648-05B2-5630C80C6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1AAA057-182E-2F17-1686-1627B967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E8B3F7B-D124-9E9F-650C-AD66A5939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621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5C0D69B-0AF0-4823-0B0C-FCA6F3062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A45F1B8-6FA9-F24E-A7B8-E672AF894C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C4F2021-F9B3-6ECB-D948-7D2A1DD6D6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4ABB24F3-5725-87D6-E596-B25563D2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EE97705-2118-3264-0F31-A80E7A21E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FBD48A-BC60-93F4-E65C-6C560EF6D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93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0053EA-AE41-F280-5C1C-352EAD13F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B02D215F-4217-D2B2-022B-B79132450C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85ED1F03-6DE3-5E96-B4A1-F0B5B9244D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89E9A00A-1253-B556-C711-90E0D9CD17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87B20BFC-6726-7EA4-45C1-001E7CA106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2C2CAF60-8F40-32A4-068A-474CDBD8D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842D5F02-0794-D1BA-6054-4EADCC5C5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55106776-BCBE-0D05-FFC8-6CEDF1707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0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B0CD0A0-B730-A5E5-3AF9-DA822D14C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D9C14C3-5393-947A-81BD-9E40267E6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6D4FB42A-A748-F389-4177-012B41EF7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44C4E2B1-EE5D-47F8-C366-BC6F5CAE1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52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2AC2C951-38E1-7D03-02A6-D3C4F66E0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69157E7-65B4-C99E-8A5D-3966C32CD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7F0F7DD2-8152-32C2-A0B8-0A471C87B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485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F4A0391-7DA4-1AA4-024D-DF0ABD123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4B7E594-C022-3DF4-D8BC-13F5A4FBED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B9405772-C60A-77FF-AA27-5EBF564ED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78505BA-4623-0389-1BBF-160FA8F70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151683F-751B-19E4-C89D-7D64AB2BA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AB07C7A-955A-F336-9011-6471032A9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219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C2DF8BB-3530-80BF-3D66-33BB2E525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79EC588-70BA-CF47-0B47-C04ED16DDA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360A111-2847-A058-9B2F-7470F593D1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7929C5E-750D-3298-7420-F93DF6CE6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F35BD6E-F04D-8DA7-09D5-59A32A95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952210B-FD69-EA75-EE82-F54B33E3E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13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BFED5CF-2DF1-DD15-5CE9-056C18840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13C1FD7-0222-4016-BDC5-A8233C651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1CDB123-0A5E-D472-0340-78BF53820B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1524D42-5138-E142-973C-A7CCDEE0E3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1940A24-1140-DA84-5533-9A882C3BDF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19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>
            <a:extLst>
              <a:ext uri="{FF2B5EF4-FFF2-40B4-BE49-F238E27FC236}">
                <a16:creationId xmlns:a16="http://schemas.microsoft.com/office/drawing/2014/main" xmlns="" id="{5A94F45D-D62C-64C4-EEC2-78150F0E673C}"/>
              </a:ext>
            </a:extLst>
          </p:cNvPr>
          <p:cNvSpPr/>
          <p:nvPr/>
        </p:nvSpPr>
        <p:spPr>
          <a:xfrm>
            <a:off x="1504557" y="585786"/>
            <a:ext cx="4486668" cy="5459414"/>
          </a:xfrm>
          <a:prstGeom prst="rect">
            <a:avLst/>
          </a:prstGeom>
          <a:solidFill>
            <a:srgbClr val="FFFF00"/>
          </a:solidFill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 dirty="0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xmlns="" id="{4549EBF1-026A-5593-B691-92F37BF839E9}"/>
              </a:ext>
            </a:extLst>
          </p:cNvPr>
          <p:cNvSpPr/>
          <p:nvPr/>
        </p:nvSpPr>
        <p:spPr>
          <a:xfrm>
            <a:off x="5991618" y="585785"/>
            <a:ext cx="4486668" cy="5459415"/>
          </a:xfrm>
          <a:prstGeom prst="rect">
            <a:avLst/>
          </a:prstGeom>
          <a:solidFill>
            <a:srgbClr val="FFFF00"/>
          </a:solidFill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 dirty="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xmlns="" id="{27EBE7DC-EE6C-227A-A220-26B262734E73}"/>
              </a:ext>
            </a:extLst>
          </p:cNvPr>
          <p:cNvSpPr/>
          <p:nvPr/>
        </p:nvSpPr>
        <p:spPr>
          <a:xfrm>
            <a:off x="1507042" y="592134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xmlns="" id="{64E675D7-E8E6-D399-8FA7-DD2078546AE4}"/>
              </a:ext>
            </a:extLst>
          </p:cNvPr>
          <p:cNvSpPr/>
          <p:nvPr/>
        </p:nvSpPr>
        <p:spPr>
          <a:xfrm>
            <a:off x="5999109" y="592134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xmlns="" id="{8D45F60C-EC35-4635-A37D-BFF6C2558D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265167"/>
              </p:ext>
            </p:extLst>
          </p:nvPr>
        </p:nvGraphicFramePr>
        <p:xfrm>
          <a:off x="6334692" y="3429000"/>
          <a:ext cx="3883052" cy="2501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xmlns="" id="{822D8207-A730-9725-98B2-E3C641D5DA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4090136"/>
              </p:ext>
            </p:extLst>
          </p:nvPr>
        </p:nvGraphicFramePr>
        <p:xfrm>
          <a:off x="6334693" y="813592"/>
          <a:ext cx="3883052" cy="2501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0" name="矩形 29">
            <a:extLst>
              <a:ext uri="{FF2B5EF4-FFF2-40B4-BE49-F238E27FC236}">
                <a16:creationId xmlns:a16="http://schemas.microsoft.com/office/drawing/2014/main" xmlns="" id="{069CD07B-B648-0E74-30A9-D22536926891}"/>
              </a:ext>
            </a:extLst>
          </p:cNvPr>
          <p:cNvSpPr/>
          <p:nvPr/>
        </p:nvSpPr>
        <p:spPr>
          <a:xfrm>
            <a:off x="4515811" y="3406625"/>
            <a:ext cx="1187029" cy="21613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ii: </a:t>
            </a:r>
            <a:r>
              <a:rPr lang="en-US" altLang="zh-CN" sz="900" b="1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WRKY62</a:t>
            </a:r>
            <a:endParaRPr lang="zh-CN" altLang="en-US" sz="900" b="1" i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xmlns="" id="{034A2C6D-D08F-B511-6305-C56D9A1C0BBA}"/>
              </a:ext>
            </a:extLst>
          </p:cNvPr>
          <p:cNvSpPr/>
          <p:nvPr/>
        </p:nvSpPr>
        <p:spPr>
          <a:xfrm>
            <a:off x="4466851" y="774527"/>
            <a:ext cx="1187029" cy="21613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</a:t>
            </a:r>
            <a:r>
              <a:rPr lang="en-US" altLang="zh-CN" sz="900" b="1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zh-CN" altLang="en-US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ADC1</a:t>
            </a:r>
            <a:endParaRPr lang="zh-CN" altLang="en-US" sz="900" b="1" i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xmlns="" id="{95FE3715-1F65-06C7-54B1-9305EC2AA13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6" t="33194" r="58533" b="43201"/>
          <a:stretch/>
        </p:blipFill>
        <p:spPr>
          <a:xfrm>
            <a:off x="2055283" y="1541312"/>
            <a:ext cx="3116792" cy="1618772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xmlns="" id="{2BF31CF9-3BB9-1EFE-7108-588EA618C0C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6" t="64584" r="58533" b="11811"/>
          <a:stretch/>
        </p:blipFill>
        <p:spPr>
          <a:xfrm>
            <a:off x="2055283" y="4115610"/>
            <a:ext cx="3116791" cy="1618772"/>
          </a:xfrm>
          <a:prstGeom prst="rect">
            <a:avLst/>
          </a:prstGeom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xmlns="" id="{7BF1900F-16AC-8CF9-F716-99BE66C51D39}"/>
              </a:ext>
            </a:extLst>
          </p:cNvPr>
          <p:cNvSpPr/>
          <p:nvPr/>
        </p:nvSpPr>
        <p:spPr>
          <a:xfrm>
            <a:off x="9030715" y="3406625"/>
            <a:ext cx="1187029" cy="21613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-ii: </a:t>
            </a:r>
            <a:r>
              <a:rPr lang="en-US" altLang="zh-CN" sz="900" b="1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WRKY62</a:t>
            </a:r>
            <a:endParaRPr lang="zh-CN" altLang="en-US" sz="900" b="1" i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xmlns="" id="{127F1701-BB91-F4BC-F66B-2790C3A0440E}"/>
              </a:ext>
            </a:extLst>
          </p:cNvPr>
          <p:cNvSpPr/>
          <p:nvPr/>
        </p:nvSpPr>
        <p:spPr>
          <a:xfrm>
            <a:off x="8981755" y="774527"/>
            <a:ext cx="1187029" cy="21613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-</a:t>
            </a:r>
            <a:r>
              <a:rPr lang="en-US" altLang="zh-CN" sz="900" b="1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zh-CN" altLang="en-US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b="1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ADC1</a:t>
            </a:r>
            <a:endParaRPr lang="zh-CN" altLang="en-US" sz="900" b="1" i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xmlns="" id="{0B98F58E-676F-00CF-911C-536FF8EB4CAB}"/>
              </a:ext>
            </a:extLst>
          </p:cNvPr>
          <p:cNvSpPr/>
          <p:nvPr/>
        </p:nvSpPr>
        <p:spPr>
          <a:xfrm>
            <a:off x="3959037" y="1198153"/>
            <a:ext cx="853678" cy="3426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" panose="02020603050405020304" pitchFamily="18" charset="0"/>
                <a:cs typeface="times" panose="02020603050405020304" pitchFamily="18" charset="0"/>
              </a:rPr>
              <a:t>Control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9CF3E2F8-416A-842D-F503-F63DE8C01394}"/>
              </a:ext>
            </a:extLst>
          </p:cNvPr>
          <p:cNvSpPr/>
          <p:nvPr/>
        </p:nvSpPr>
        <p:spPr>
          <a:xfrm>
            <a:off x="3026534" y="1198658"/>
            <a:ext cx="853678" cy="3426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" panose="02020603050405020304" pitchFamily="18" charset="0"/>
                <a:cs typeface="times" panose="02020603050405020304" pitchFamily="18" charset="0"/>
              </a:rPr>
              <a:t>OE-9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xmlns="" id="{FE98A0CD-9CD2-9E39-6D75-1868CFBB3AEC}"/>
              </a:ext>
            </a:extLst>
          </p:cNvPr>
          <p:cNvSpPr/>
          <p:nvPr/>
        </p:nvSpPr>
        <p:spPr>
          <a:xfrm>
            <a:off x="3532002" y="1198658"/>
            <a:ext cx="853678" cy="3426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" panose="02020603050405020304" pitchFamily="18" charset="0"/>
                <a:cs typeface="times" panose="02020603050405020304" pitchFamily="18" charset="0"/>
              </a:rPr>
              <a:t>OE-6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xmlns="" id="{D043674B-4114-5F33-8324-0F0B730E8161}"/>
              </a:ext>
            </a:extLst>
          </p:cNvPr>
          <p:cNvSpPr/>
          <p:nvPr/>
        </p:nvSpPr>
        <p:spPr>
          <a:xfrm>
            <a:off x="4073717" y="3764310"/>
            <a:ext cx="853678" cy="3426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" panose="02020603050405020304" pitchFamily="18" charset="0"/>
                <a:cs typeface="times" panose="02020603050405020304" pitchFamily="18" charset="0"/>
              </a:rPr>
              <a:t>Control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xmlns="" id="{846DC3D8-7A53-0574-E1B9-73486ED3C7C6}"/>
              </a:ext>
            </a:extLst>
          </p:cNvPr>
          <p:cNvSpPr/>
          <p:nvPr/>
        </p:nvSpPr>
        <p:spPr>
          <a:xfrm>
            <a:off x="3064500" y="3770603"/>
            <a:ext cx="853678" cy="3426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" panose="02020603050405020304" pitchFamily="18" charset="0"/>
                <a:cs typeface="times" panose="02020603050405020304" pitchFamily="18" charset="0"/>
              </a:rPr>
              <a:t>OE-13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xmlns="" id="{A9D30674-C493-1BB7-6765-A8D95AE5B03A}"/>
              </a:ext>
            </a:extLst>
          </p:cNvPr>
          <p:cNvSpPr/>
          <p:nvPr/>
        </p:nvSpPr>
        <p:spPr>
          <a:xfrm>
            <a:off x="3569968" y="3770603"/>
            <a:ext cx="853678" cy="3426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" panose="02020603050405020304" pitchFamily="18" charset="0"/>
                <a:cs typeface="times" panose="02020603050405020304" pitchFamily="18" charset="0"/>
              </a:rPr>
              <a:t>OE-8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D038AB9E-F330-4D0A-6A30-66868EC2AA56}"/>
              </a:ext>
            </a:extLst>
          </p:cNvPr>
          <p:cNvSpPr txBox="1"/>
          <p:nvPr/>
        </p:nvSpPr>
        <p:spPr>
          <a:xfrm>
            <a:off x="11172829" y="0"/>
            <a:ext cx="1019171" cy="38093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ctr">
              <a:defRPr b="1"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defRPr>
            </a:lvl1pPr>
          </a:lstStyle>
          <a:p>
            <a:r>
              <a:rPr lang="en-US" altLang="zh-CN" dirty="0"/>
              <a:t>Fig. S7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46008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31</TotalTime>
  <Words>37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ixin</dc:creator>
  <cp:lastModifiedBy>Rene Carl Ventolero</cp:lastModifiedBy>
  <cp:revision>892</cp:revision>
  <dcterms:created xsi:type="dcterms:W3CDTF">2022-06-09T13:36:42Z</dcterms:created>
  <dcterms:modified xsi:type="dcterms:W3CDTF">2024-01-22T13:42:36Z</dcterms:modified>
</cp:coreProperties>
</file>